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0" d="100"/>
          <a:sy n="50" d="100"/>
        </p:scale>
        <p:origin x="-2364" y="-13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61939132608424"/>
          <c:y val="6.168066491688539E-2"/>
          <c:w val="0.77982002249718785"/>
          <c:h val="0.799143482064741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D$39</c:f>
              <c:strCache>
                <c:ptCount val="1"/>
                <c:pt idx="0">
                  <c:v>HO-1 +/+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G$39:$H$39</c:f>
                <c:numCache>
                  <c:formatCode>General</c:formatCode>
                  <c:ptCount val="2"/>
                  <c:pt idx="0">
                    <c:v>5.6798000000000001E-2</c:v>
                  </c:pt>
                  <c:pt idx="1">
                    <c:v>3.549780000000000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E$38:$F$38</c:f>
              <c:strCache>
                <c:ptCount val="2"/>
                <c:pt idx="0">
                  <c:v>unmobilized </c:v>
                </c:pt>
                <c:pt idx="1">
                  <c:v>G-CSF</c:v>
                </c:pt>
              </c:strCache>
            </c:strRef>
          </c:cat>
          <c:val>
            <c:numRef>
              <c:f>Sheet1!$E$39:$F$39</c:f>
              <c:numCache>
                <c:formatCode>General</c:formatCode>
                <c:ptCount val="2"/>
                <c:pt idx="0">
                  <c:v>0.80130899999999994</c:v>
                </c:pt>
                <c:pt idx="1">
                  <c:v>0.82296599999999998</c:v>
                </c:pt>
              </c:numCache>
            </c:numRef>
          </c:val>
        </c:ser>
        <c:ser>
          <c:idx val="1"/>
          <c:order val="1"/>
          <c:tx>
            <c:strRef>
              <c:f>Sheet1!$D$40</c:f>
              <c:strCache>
                <c:ptCount val="1"/>
                <c:pt idx="0">
                  <c:v>HO-1 +/-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G$40:$H$40</c:f>
                <c:numCache>
                  <c:formatCode>General</c:formatCode>
                  <c:ptCount val="2"/>
                  <c:pt idx="0">
                    <c:v>4.87987E-2</c:v>
                  </c:pt>
                  <c:pt idx="1">
                    <c:v>5.687899999999999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E$38:$F$38</c:f>
              <c:strCache>
                <c:ptCount val="2"/>
                <c:pt idx="0">
                  <c:v>unmobilized </c:v>
                </c:pt>
                <c:pt idx="1">
                  <c:v>G-CSF</c:v>
                </c:pt>
              </c:strCache>
            </c:strRef>
          </c:cat>
          <c:val>
            <c:numRef>
              <c:f>Sheet1!$E$40:$F$40</c:f>
              <c:numCache>
                <c:formatCode>General</c:formatCode>
                <c:ptCount val="2"/>
                <c:pt idx="0">
                  <c:v>0.73633800000000005</c:v>
                </c:pt>
                <c:pt idx="1">
                  <c:v>0.90959400000000001</c:v>
                </c:pt>
              </c:numCache>
            </c:numRef>
          </c:val>
        </c:ser>
        <c:ser>
          <c:idx val="2"/>
          <c:order val="2"/>
          <c:tx>
            <c:strRef>
              <c:f>Sheet1!$D$41</c:f>
              <c:strCache>
                <c:ptCount val="1"/>
                <c:pt idx="0">
                  <c:v>HO-1 -/-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G$41:$H$41</c:f>
                <c:numCache>
                  <c:formatCode>General</c:formatCode>
                  <c:ptCount val="2"/>
                  <c:pt idx="0">
                    <c:v>0.1149877</c:v>
                  </c:pt>
                  <c:pt idx="1">
                    <c:v>7.9879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E$38:$F$38</c:f>
              <c:strCache>
                <c:ptCount val="2"/>
                <c:pt idx="0">
                  <c:v>unmobilized </c:v>
                </c:pt>
                <c:pt idx="1">
                  <c:v>G-CSF</c:v>
                </c:pt>
              </c:strCache>
            </c:strRef>
          </c:cat>
          <c:val>
            <c:numRef>
              <c:f>Sheet1!$E$41:$F$41</c:f>
              <c:numCache>
                <c:formatCode>General</c:formatCode>
                <c:ptCount val="2"/>
                <c:pt idx="0">
                  <c:v>0.76521400000000006</c:v>
                </c:pt>
                <c:pt idx="1">
                  <c:v>0.895156000000000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3297792"/>
        <c:axId val="83299328"/>
      </c:barChart>
      <c:catAx>
        <c:axId val="83297792"/>
        <c:scaling>
          <c:orientation val="minMax"/>
        </c:scaling>
        <c:delete val="0"/>
        <c:axPos val="b"/>
        <c:majorTickMark val="out"/>
        <c:minorTickMark val="none"/>
        <c:tickLblPos val="nextTo"/>
        <c:crossAx val="83299328"/>
        <c:crosses val="autoZero"/>
        <c:auto val="1"/>
        <c:lblAlgn val="ctr"/>
        <c:lblOffset val="100"/>
        <c:noMultiLvlLbl val="0"/>
      </c:catAx>
      <c:valAx>
        <c:axId val="83299328"/>
        <c:scaling>
          <c:orientation val="minMax"/>
          <c:max val="1.6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SDF-1 (ng/m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329779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6252187226596676"/>
          <c:y val="3.819772528433947E-2"/>
          <c:w val="0.81366860392450946"/>
          <c:h val="9.0270778652668401E-2"/>
        </c:manualLayout>
      </c:layout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200" b="1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B21A8C-F44E-4A74-90B6-B231215D0EDF}" type="datetimeFigureOut">
              <a:rPr lang="en-US" smtClean="0"/>
              <a:t>6/20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FF6B46-8FC0-4349-8CEB-303A90511F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7165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A7EDC-9767-495B-809A-BB443BBFDF99}" type="datetimeFigureOut">
              <a:rPr lang="en-US" smtClean="0"/>
              <a:t>6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13BE7-D215-4E7B-8BFB-E8CFA8AD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3057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A7EDC-9767-495B-809A-BB443BBFDF99}" type="datetimeFigureOut">
              <a:rPr lang="en-US" smtClean="0"/>
              <a:t>6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13BE7-D215-4E7B-8BFB-E8CFA8AD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8919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A7EDC-9767-495B-809A-BB443BBFDF99}" type="datetimeFigureOut">
              <a:rPr lang="en-US" smtClean="0"/>
              <a:t>6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13BE7-D215-4E7B-8BFB-E8CFA8AD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07219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A7EDC-9767-495B-809A-BB443BBFDF99}" type="datetimeFigureOut">
              <a:rPr lang="en-US" smtClean="0"/>
              <a:t>6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13BE7-D215-4E7B-8BFB-E8CFA8AD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4499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A7EDC-9767-495B-809A-BB443BBFDF99}" type="datetimeFigureOut">
              <a:rPr lang="en-US" smtClean="0"/>
              <a:t>6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13BE7-D215-4E7B-8BFB-E8CFA8AD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6506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A7EDC-9767-495B-809A-BB443BBFDF99}" type="datetimeFigureOut">
              <a:rPr lang="en-US" smtClean="0"/>
              <a:t>6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13BE7-D215-4E7B-8BFB-E8CFA8AD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7851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A7EDC-9767-495B-809A-BB443BBFDF99}" type="datetimeFigureOut">
              <a:rPr lang="en-US" smtClean="0"/>
              <a:t>6/20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13BE7-D215-4E7B-8BFB-E8CFA8AD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9904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A7EDC-9767-495B-809A-BB443BBFDF99}" type="datetimeFigureOut">
              <a:rPr lang="en-US" smtClean="0"/>
              <a:t>6/20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13BE7-D215-4E7B-8BFB-E8CFA8AD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059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A7EDC-9767-495B-809A-BB443BBFDF99}" type="datetimeFigureOut">
              <a:rPr lang="en-US" smtClean="0"/>
              <a:t>6/20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13BE7-D215-4E7B-8BFB-E8CFA8AD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564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A7EDC-9767-495B-809A-BB443BBFDF99}" type="datetimeFigureOut">
              <a:rPr lang="en-US" smtClean="0"/>
              <a:t>6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13BE7-D215-4E7B-8BFB-E8CFA8AD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3091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8A7EDC-9767-495B-809A-BB443BBFDF99}" type="datetimeFigureOut">
              <a:rPr lang="en-US" smtClean="0"/>
              <a:t>6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13BE7-D215-4E7B-8BFB-E8CFA8AD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39597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8A7EDC-9767-495B-809A-BB443BBFDF99}" type="datetimeFigureOut">
              <a:rPr lang="en-US" smtClean="0"/>
              <a:t>6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F13BE7-D215-4E7B-8BFB-E8CFA8AD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2553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4399998" y="8774668"/>
            <a:ext cx="27271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 Supplementary Figure 1</a:t>
            </a:r>
            <a:endParaRPr lang="en-US" b="1" dirty="0"/>
          </a:p>
        </p:txBody>
      </p:sp>
      <p:graphicFrame>
        <p:nvGraphicFramePr>
          <p:cNvPr id="16" name="Char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6761886"/>
              </p:ext>
            </p:extLst>
          </p:nvPr>
        </p:nvGraphicFramePr>
        <p:xfrm>
          <a:off x="1819275" y="876300"/>
          <a:ext cx="320040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4" name="Picture 7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7800" y="4796790"/>
            <a:ext cx="1989920" cy="182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ectangle 4"/>
          <p:cNvSpPr/>
          <p:nvPr/>
        </p:nvSpPr>
        <p:spPr>
          <a:xfrm>
            <a:off x="1524000" y="4724400"/>
            <a:ext cx="2011680" cy="20116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pic>
        <p:nvPicPr>
          <p:cNvPr id="6" name="Picture 8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42428" y="4815840"/>
            <a:ext cx="1968758" cy="182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Rectangle 6"/>
          <p:cNvSpPr/>
          <p:nvPr/>
        </p:nvSpPr>
        <p:spPr>
          <a:xfrm>
            <a:off x="3686175" y="4714875"/>
            <a:ext cx="2011680" cy="20116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" name="Right Arrow 7"/>
          <p:cNvSpPr/>
          <p:nvPr/>
        </p:nvSpPr>
        <p:spPr>
          <a:xfrm>
            <a:off x="3192848" y="5867400"/>
            <a:ext cx="822960" cy="182880"/>
          </a:xfrm>
          <a:prstGeom prst="rightArrow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1417854" y="438090"/>
            <a:ext cx="41094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A.</a:t>
            </a:r>
            <a:endParaRPr lang="en-US" sz="20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419225" y="4095690"/>
            <a:ext cx="3978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B.</a:t>
            </a:r>
            <a:endParaRPr lang="en-US" sz="2000" b="1" dirty="0"/>
          </a:p>
        </p:txBody>
      </p:sp>
      <p:sp>
        <p:nvSpPr>
          <p:cNvPr id="2" name="Rectangle 1"/>
          <p:cNvSpPr/>
          <p:nvPr/>
        </p:nvSpPr>
        <p:spPr>
          <a:xfrm>
            <a:off x="1066800" y="438090"/>
            <a:ext cx="4800600" cy="31433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/>
          <p:cNvSpPr/>
          <p:nvPr/>
        </p:nvSpPr>
        <p:spPr>
          <a:xfrm>
            <a:off x="1066800" y="3886200"/>
            <a:ext cx="4800600" cy="33528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505560" y="7574339"/>
            <a:ext cx="589524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b="1" dirty="0"/>
              <a:t>Panel A – </a:t>
            </a:r>
            <a:r>
              <a:rPr lang="fr-FR" dirty="0"/>
              <a:t>plasma </a:t>
            </a:r>
            <a:r>
              <a:rPr lang="fr-FR" dirty="0" err="1"/>
              <a:t>level</a:t>
            </a:r>
            <a:r>
              <a:rPr lang="fr-FR" dirty="0"/>
              <a:t> of SDF-1 in </a:t>
            </a:r>
            <a:r>
              <a:rPr lang="fr-FR" dirty="0" smtClean="0"/>
              <a:t>G-CSF </a:t>
            </a:r>
            <a:r>
              <a:rPr lang="fr-FR" dirty="0" err="1" smtClean="0"/>
              <a:t>mobilized</a:t>
            </a:r>
            <a:r>
              <a:rPr lang="fr-FR" dirty="0" smtClean="0"/>
              <a:t> </a:t>
            </a:r>
            <a:r>
              <a:rPr lang="fr-FR" dirty="0"/>
              <a:t>HO-1-deficient and control </a:t>
            </a:r>
            <a:r>
              <a:rPr lang="fr-FR" dirty="0" err="1"/>
              <a:t>mice</a:t>
            </a:r>
            <a:r>
              <a:rPr lang="fr-FR" dirty="0"/>
              <a:t> </a:t>
            </a:r>
            <a:r>
              <a:rPr lang="fr-FR" dirty="0" err="1"/>
              <a:t>measured</a:t>
            </a:r>
            <a:r>
              <a:rPr lang="fr-FR" dirty="0"/>
              <a:t> by ELISA.</a:t>
            </a:r>
            <a:r>
              <a:rPr lang="fr-FR" b="1" dirty="0"/>
              <a:t> Panel B – </a:t>
            </a:r>
            <a:r>
              <a:rPr lang="fr-FR" dirty="0" err="1"/>
              <a:t>gating</a:t>
            </a:r>
            <a:r>
              <a:rPr lang="fr-FR" dirty="0"/>
              <a:t> </a:t>
            </a:r>
            <a:r>
              <a:rPr lang="fr-FR" dirty="0" err="1"/>
              <a:t>strategy</a:t>
            </a:r>
            <a:r>
              <a:rPr lang="fr-FR" dirty="0"/>
              <a:t> to sort Gr-1</a:t>
            </a:r>
            <a:r>
              <a:rPr lang="fr-FR" baseline="30000" dirty="0"/>
              <a:t>+</a:t>
            </a:r>
            <a:r>
              <a:rPr lang="fr-FR" dirty="0"/>
              <a:t> granulocytes </a:t>
            </a:r>
            <a:r>
              <a:rPr lang="fr-FR" dirty="0" err="1"/>
              <a:t>from</a:t>
            </a:r>
            <a:r>
              <a:rPr lang="fr-FR" dirty="0"/>
              <a:t> BM.</a:t>
            </a:r>
            <a:endParaRPr lang="en-US" dirty="0"/>
          </a:p>
          <a:p>
            <a:pPr algn="just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866433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</TotalTime>
  <Words>43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cin</dc:creator>
  <cp:lastModifiedBy>Ratajczak,Mariusz</cp:lastModifiedBy>
  <cp:revision>14</cp:revision>
  <dcterms:created xsi:type="dcterms:W3CDTF">2014-03-04T15:10:08Z</dcterms:created>
  <dcterms:modified xsi:type="dcterms:W3CDTF">2014-06-20T09:53:48Z</dcterms:modified>
</cp:coreProperties>
</file>